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4" r:id="rId2"/>
  </p:sldIdLst>
  <p:sldSz cx="12192000" cy="16256000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226" autoAdjust="0"/>
  </p:normalViewPr>
  <p:slideViewPr>
    <p:cSldViewPr snapToGrid="0">
      <p:cViewPr>
        <p:scale>
          <a:sx n="60" d="100"/>
          <a:sy n="60" d="100"/>
        </p:scale>
        <p:origin x="1550" y="-12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84B9-994B-4473-A409-0FBCBDB509EE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70113" y="1243013"/>
            <a:ext cx="2517775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86313"/>
            <a:ext cx="5486400" cy="39163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37F0B2-FB5E-4C97-BBD1-890B1EEB6A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4971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295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891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0071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695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864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834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150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8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032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004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379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1538-4C44-4AEE-9F6F-20764E9CF59D}" type="datetimeFigureOut">
              <a:rPr kumimoji="1" lang="ja-JP" altLang="en-US" smtClean="0"/>
              <a:t>2018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8787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2746" y="10815226"/>
            <a:ext cx="3593627" cy="2373878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75783" y="7983813"/>
            <a:ext cx="3593627" cy="2373878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98935" y="10815456"/>
            <a:ext cx="3482810" cy="2373878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94469" y="7978636"/>
            <a:ext cx="3593627" cy="2373878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70825" y="5120110"/>
            <a:ext cx="3593627" cy="2373878"/>
          </a:xfrm>
          <a:prstGeom prst="rect">
            <a:avLst/>
          </a:prstGeom>
        </p:spPr>
      </p:pic>
      <p:pic>
        <p:nvPicPr>
          <p:cNvPr id="27" name="図 2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91691" y="5116229"/>
            <a:ext cx="3593627" cy="2373878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00982" y="2255251"/>
            <a:ext cx="3593627" cy="2373878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70000" y="2247405"/>
            <a:ext cx="3593627" cy="2373878"/>
          </a:xfrm>
          <a:prstGeom prst="rect">
            <a:avLst/>
          </a:prstGeom>
        </p:spPr>
      </p:pic>
      <p:cxnSp>
        <p:nvCxnSpPr>
          <p:cNvPr id="78" name="直線コネクタ 77"/>
          <p:cNvCxnSpPr/>
          <p:nvPr/>
        </p:nvCxnSpPr>
        <p:spPr>
          <a:xfrm>
            <a:off x="7518400" y="11000740"/>
            <a:ext cx="21717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/>
          <p:cNvCxnSpPr/>
          <p:nvPr/>
        </p:nvCxnSpPr>
        <p:spPr>
          <a:xfrm flipH="1">
            <a:off x="7518400" y="11140440"/>
            <a:ext cx="14605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/>
          <p:cNvCxnSpPr/>
          <p:nvPr/>
        </p:nvCxnSpPr>
        <p:spPr>
          <a:xfrm>
            <a:off x="3213100" y="11112500"/>
            <a:ext cx="21717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 flipH="1">
            <a:off x="3213100" y="11264900"/>
            <a:ext cx="14605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 rot="16200000">
            <a:off x="1085552" y="2975676"/>
            <a:ext cx="22297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smtClean="0"/>
              <a:t>IRS-1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082904" y="14016814"/>
            <a:ext cx="1046476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b="1" dirty="0" smtClean="0"/>
              <a:t>Supplementary Figure 2.  Gene expression levels in the livers of subjects by NAFLD activity score (NAS). </a:t>
            </a:r>
          </a:p>
          <a:p>
            <a:r>
              <a:rPr lang="en-US" altLang="ja-JP" dirty="0" smtClean="0"/>
              <a:t>The hepatic gene expression levels were compared among NAS=0, 1-2, 3-4, and 5-8. Individual genes are normalized to CDKN1B mRNA levels. IRS-1 (a), IRS-2 (b), PEPCK (c), G6Pase (d), GCK (e), FAS (f), IR (g), and the IR-B/IR-A ratio (h). Data </a:t>
            </a:r>
            <a:r>
              <a:rPr lang="en-US" altLang="ja-JP" smtClean="0"/>
              <a:t>from 51 </a:t>
            </a:r>
            <a:r>
              <a:rPr lang="en-US" altLang="ja-JP" dirty="0" smtClean="0"/>
              <a:t>human liver biopsies are shown. The top and bottom of each box indicate the 1</a:t>
            </a:r>
            <a:r>
              <a:rPr lang="en-US" altLang="ja-JP" baseline="30000" dirty="0" smtClean="0"/>
              <a:t>st</a:t>
            </a:r>
            <a:r>
              <a:rPr lang="en-US" altLang="ja-JP" dirty="0" smtClean="0"/>
              <a:t> and 3</a:t>
            </a:r>
            <a:r>
              <a:rPr lang="en-US" altLang="ja-JP" baseline="30000" dirty="0" smtClean="0"/>
              <a:t>rd</a:t>
            </a:r>
            <a:r>
              <a:rPr lang="en-US" altLang="ja-JP" dirty="0" smtClean="0"/>
              <a:t> quartiles (interquartile range, IGR), and the band inside the box in the median. The ends of the whiskers represent the minima and maxima without outliers. The </a:t>
            </a:r>
            <a:r>
              <a:rPr lang="en-US" altLang="ja-JP" i="1" dirty="0" smtClean="0"/>
              <a:t>P</a:t>
            </a:r>
            <a:r>
              <a:rPr lang="en-US" altLang="ja-JP" dirty="0" smtClean="0"/>
              <a:t> value was determined by ANOVA with Tukey-Kramer post hoc testing. (</a:t>
            </a:r>
            <a:r>
              <a:rPr lang="ja-JP" altLang="en-US" sz="1400" baseline="30000" dirty="0" smtClean="0"/>
              <a:t>✱</a:t>
            </a:r>
            <a:r>
              <a:rPr lang="en-US" altLang="ja-JP" i="1" dirty="0" smtClean="0"/>
              <a:t>P</a:t>
            </a:r>
            <a:r>
              <a:rPr lang="en-US" altLang="ja-JP" dirty="0" smtClean="0"/>
              <a:t>&lt;0.05, </a:t>
            </a:r>
            <a:r>
              <a:rPr lang="ja-JP" altLang="en-US" sz="1400" baseline="30000" dirty="0" smtClean="0"/>
              <a:t>✱✱</a:t>
            </a:r>
            <a:r>
              <a:rPr lang="en-US" altLang="ja-JP" i="1" dirty="0" smtClean="0"/>
              <a:t>P</a:t>
            </a:r>
            <a:r>
              <a:rPr lang="en-US" altLang="ja-JP" dirty="0" smtClean="0"/>
              <a:t>&lt;0.01).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11044" y="388993"/>
            <a:ext cx="113204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600" dirty="0" smtClean="0"/>
              <a:t>Supplementary</a:t>
            </a:r>
            <a:r>
              <a:rPr kumimoji="1" lang="en-US" altLang="ja-JP" sz="3600" dirty="0" smtClean="0"/>
              <a:t> Figure 2</a:t>
            </a:r>
            <a:r>
              <a:rPr kumimoji="1" lang="ja-JP" altLang="en-US" sz="3600" dirty="0" smtClean="0"/>
              <a:t>　　　　　　　　　　　　</a:t>
            </a:r>
            <a:r>
              <a:rPr kumimoji="1" lang="en-US" altLang="ja-JP" sz="3600" dirty="0" err="1" smtClean="0"/>
              <a:t>Honma</a:t>
            </a:r>
            <a:r>
              <a:rPr lang="ja-JP" altLang="en-US" sz="3600" dirty="0"/>
              <a:t> </a:t>
            </a:r>
            <a:r>
              <a:rPr lang="en-US" altLang="ja-JP" sz="3600" smtClean="0"/>
              <a:t>M</a:t>
            </a:r>
            <a:r>
              <a:rPr kumimoji="1" lang="en-US" altLang="ja-JP" sz="3600" smtClean="0"/>
              <a:t>, </a:t>
            </a:r>
            <a:r>
              <a:rPr kumimoji="1" lang="en-US" altLang="ja-JP" sz="3600" dirty="0" smtClean="0"/>
              <a:t>et al.</a:t>
            </a:r>
            <a:endParaRPr kumimoji="1" lang="ja-JP" altLang="en-US" sz="36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263776" y="4682175"/>
            <a:ext cx="134911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c)                                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          　　　　</a:t>
            </a:r>
            <a:r>
              <a:rPr lang="ja-JP" alt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d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lang="ja-JP" altLang="en-US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263776" y="7546025"/>
            <a:ext cx="134911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e)                                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          　　　　</a:t>
            </a:r>
            <a:r>
              <a:rPr lang="ja-JP" alt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lang="ja-JP" altLang="en-US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263776" y="1811975"/>
            <a:ext cx="134911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a)                                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          　　　　</a:t>
            </a:r>
            <a:r>
              <a:rPr lang="ja-JP" alt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b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lang="ja-JP" altLang="en-US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5592985" y="2961466"/>
            <a:ext cx="17565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IRS-2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1292506" y="5784424"/>
            <a:ext cx="18213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/>
              <a:t>PEPCK</a:t>
            </a:r>
            <a:r>
              <a:rPr kumimoji="1" lang="en-US" altLang="ja-JP" sz="1400" dirty="0" smtClean="0"/>
              <a:t>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5570511" y="5783406"/>
            <a:ext cx="18014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 smtClean="0"/>
              <a:t>G6Pase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1330506" y="8699010"/>
            <a:ext cx="17565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/>
              <a:t>GCK</a:t>
            </a:r>
            <a:r>
              <a:rPr kumimoji="1" lang="en-US" altLang="ja-JP" sz="1400" dirty="0" smtClean="0"/>
              <a:t>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5605685" y="8696786"/>
            <a:ext cx="17565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/>
              <a:t>FAS</a:t>
            </a:r>
            <a:r>
              <a:rPr kumimoji="1" lang="en-US" altLang="ja-JP" sz="1400" dirty="0" smtClean="0"/>
              <a:t>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35" name="テキスト ボックス 34"/>
          <p:cNvSpPr txBox="1"/>
          <p:nvPr/>
        </p:nvSpPr>
        <p:spPr>
          <a:xfrm rot="16200000">
            <a:off x="1330506" y="11531110"/>
            <a:ext cx="17565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/>
              <a:t>IR</a:t>
            </a:r>
            <a:r>
              <a:rPr kumimoji="1" lang="en-US" altLang="ja-JP" sz="1400" dirty="0" smtClean="0"/>
              <a:t> mRNA</a:t>
            </a:r>
          </a:p>
          <a:p>
            <a:pPr algn="ctr"/>
            <a:r>
              <a:rPr lang="en-US" altLang="ja-JP" sz="1400" dirty="0" smtClean="0"/>
              <a:t>log transformed (AU) </a:t>
            </a:r>
            <a:endParaRPr kumimoji="1" lang="ja-JP" altLang="en-US" sz="1400" dirty="0"/>
          </a:p>
        </p:txBody>
      </p:sp>
      <p:sp>
        <p:nvSpPr>
          <p:cNvPr id="36" name="テキスト ボックス 35"/>
          <p:cNvSpPr txBox="1"/>
          <p:nvPr/>
        </p:nvSpPr>
        <p:spPr>
          <a:xfrm rot="16200000">
            <a:off x="5473880" y="11695709"/>
            <a:ext cx="2310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smtClean="0"/>
              <a:t>IR-B / IR-A</a:t>
            </a:r>
            <a:r>
              <a:rPr kumimoji="1" lang="en-US" altLang="ja-JP" sz="1400" dirty="0" smtClean="0"/>
              <a:t> mRNA </a:t>
            </a:r>
            <a:r>
              <a:rPr lang="en-US" altLang="ja-JP" sz="1400" dirty="0" smtClean="0"/>
              <a:t>ratio </a:t>
            </a:r>
            <a:endParaRPr kumimoji="1" lang="ja-JP" altLang="en-US" sz="14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8031983" y="544239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8398348" y="524393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7692933" y="565729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756441" y="542671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086034" y="525131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413529" y="558142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endParaRPr lang="ja-JP" altLang="en-US" sz="800" dirty="0"/>
          </a:p>
        </p:txBody>
      </p:sp>
      <p:cxnSp>
        <p:nvCxnSpPr>
          <p:cNvPr id="47" name="直線コネクタ 46"/>
          <p:cNvCxnSpPr/>
          <p:nvPr/>
        </p:nvCxnSpPr>
        <p:spPr>
          <a:xfrm>
            <a:off x="3177176" y="5740400"/>
            <a:ext cx="7599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 flipH="1">
            <a:off x="3175000" y="5588000"/>
            <a:ext cx="14605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3175000" y="5412740"/>
            <a:ext cx="21717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7492636" y="5816600"/>
            <a:ext cx="7599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 flipH="1">
            <a:off x="7490460" y="5598160"/>
            <a:ext cx="14605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7490460" y="5407660"/>
            <a:ext cx="21717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7487556" y="2705100"/>
            <a:ext cx="7599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 flipH="1">
            <a:off x="7493000" y="2570480"/>
            <a:ext cx="14605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7493000" y="2435860"/>
            <a:ext cx="21717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>
            <a:off x="8023131" y="240637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8407758" y="228118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7707079" y="2548614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7761144" y="1111093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endParaRPr kumimoji="1" lang="ja-JP" altLang="en-US" sz="800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8040784" y="1097017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8382355" y="1084605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3759526" y="1109980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800" dirty="0" smtClean="0"/>
              <a:t>✱</a:t>
            </a:r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4161269" y="1094863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800" dirty="0" smtClean="0"/>
              <a:t>✱</a:t>
            </a:r>
            <a:endParaRPr lang="ja-JP" altLang="en-US" sz="800" dirty="0"/>
          </a:p>
        </p:txBody>
      </p:sp>
      <p:cxnSp>
        <p:nvCxnSpPr>
          <p:cNvPr id="76" name="直線コネクタ 75"/>
          <p:cNvCxnSpPr/>
          <p:nvPr/>
        </p:nvCxnSpPr>
        <p:spPr>
          <a:xfrm>
            <a:off x="7520576" y="11267440"/>
            <a:ext cx="75996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/>
          <p:cNvSpPr txBox="1"/>
          <p:nvPr/>
        </p:nvSpPr>
        <p:spPr>
          <a:xfrm>
            <a:off x="2855900" y="4294747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7133984" y="4294747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2855901" y="7146800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7133985" y="7146800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2855901" y="10009742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133985" y="10009742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2855901" y="12850912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7133985" y="12850912"/>
            <a:ext cx="285727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/>
              <a:t>NAS = 0</a:t>
            </a:r>
            <a:r>
              <a:rPr kumimoji="1" lang="ja-JP" altLang="en-US" sz="1400" dirty="0" smtClean="0"/>
              <a:t>　　  </a:t>
            </a:r>
            <a:r>
              <a:rPr kumimoji="1" lang="en-US" altLang="ja-JP" sz="1400" dirty="0" smtClean="0"/>
              <a:t>1 - 2          3 - 4           5 - 8</a:t>
            </a:r>
            <a:r>
              <a:rPr kumimoji="1" lang="ja-JP" altLang="en-US" sz="1400" dirty="0" smtClean="0"/>
              <a:t> </a:t>
            </a:r>
            <a:r>
              <a:rPr kumimoji="1" lang="en-US" altLang="ja-JP" sz="1400" dirty="0" smtClean="0"/>
              <a:t>	</a:t>
            </a:r>
            <a:endParaRPr lang="ja-JP" altLang="en-US" sz="1400" dirty="0"/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263776" y="10390825"/>
            <a:ext cx="134911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g)                                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         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　　　　</a:t>
            </a:r>
            <a:r>
              <a:rPr lang="ja-JP" alt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ja-JP" altLang="en-US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 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</a:t>
            </a:r>
            <a:r>
              <a:rPr lang="en-US" altLang="ja-JP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h</a:t>
            </a:r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)</a:t>
            </a:r>
            <a:endParaRPr lang="ja-JP" altLang="en-US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6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8</TotalTime>
  <Words>270</Words>
  <Application>Microsoft Office PowerPoint</Application>
  <PresentationFormat>ユーザー設定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washow</dc:creator>
  <cp:lastModifiedBy>sawashow</cp:lastModifiedBy>
  <cp:revision>80</cp:revision>
  <cp:lastPrinted>2018-01-07T01:52:10Z</cp:lastPrinted>
  <dcterms:created xsi:type="dcterms:W3CDTF">2016-03-17T09:26:04Z</dcterms:created>
  <dcterms:modified xsi:type="dcterms:W3CDTF">2018-01-31T12:46:28Z</dcterms:modified>
</cp:coreProperties>
</file>